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5"/>
  </p:normalViewPr>
  <p:slideViewPr>
    <p:cSldViewPr snapToGrid="0" snapToObjects="1">
      <p:cViewPr varScale="1">
        <p:scale>
          <a:sx n="110" d="100"/>
          <a:sy n="110" d="100"/>
        </p:scale>
        <p:origin x="6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BD883D-1C72-D147-B247-B0D0803B71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F293229-2D0D-534D-A120-34066CBAD0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D31133-31C6-3C45-9A8C-33AD7A0FF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7F9AC2-7227-7444-9BF1-E67843B06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ADCCE9-ACA3-BA40-B5FE-030D64B49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4224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312637-69C8-0B49-B924-68BF114A62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7C1D095-B7AF-9141-BA91-4A2934D0B8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28445-8A5A-1D4F-8113-4A6C1DCB1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411961-344D-8E4B-B039-4735C1C36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7E4F85-BB58-7744-BC99-6F582D649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66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EE25CB5-E23A-D945-92B7-99562AFED4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3F8589E-C85B-7342-BF58-DFF225B7A4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18185D-3CD8-A243-960C-61FF46FDD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8DC969-BCCD-174D-88A6-C49647025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083C92-A9D1-4D47-BBFD-CAD8FBB50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288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F85DAB-CCFB-C640-8E59-435E1ED4BE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D6E16DA-2663-2B47-B740-FFD67D7383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F3C7C4-A76A-3B4F-9010-37A5E98BA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8CAC3F-21D9-4A41-84CB-811AE5428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239974-2AE1-9449-97E8-A31E36B75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520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CC20E6-73A1-6F43-858B-E69A8671E1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1925FF-EF8A-3145-AB5B-870BD76801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50D145-FFF8-704E-A33F-945477376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43C070-85D6-864B-90EF-F4A919672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4D622E-9401-9D4D-850A-AB99C3548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832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27C7B7-00DB-3D40-8ED1-F6A0E8EA2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D4D069-654C-A94A-AF25-3127D088F8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8408622-622A-0946-A2D0-3D2CD1B1AB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65570DF-7549-CB4A-8C40-C6252763A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2468F08-04D7-0D42-95D4-C5D5234BF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FFB0F7-472C-0248-A79B-08E7E1E32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4391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58423F-5FAE-2145-BDC0-806650B8C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6FABA02-0EA3-D443-BDA4-67CAAF2458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1D5D04-7B67-2048-AC08-1BBA0441FC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60C7855-9D57-1B44-B160-7CD8FB0162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D40AA55-D2F7-B84B-8ED1-1181528D95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E0A6FC6-8086-5F4F-A5D3-A11EB62AC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885EBC1-8245-D947-9749-181974C2F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A04A8F0-EF08-F646-8628-B4D5E2C72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4298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CA4565-A515-F14D-B45B-96D8012734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A80A731-3048-EB41-9850-0F67645B2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5171B76-DE61-2344-BDA1-AED9B0A0B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302B45A-AE27-A54A-9642-58CAED29E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935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00E139A-8181-0B49-8496-94F81C126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45C7F06-7DA2-3B44-8105-0CC4B1862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980A23D-D90A-6244-A085-8B164F399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45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31CFC6-4ED2-534B-B3F3-583BFB3467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80CEDA-3F96-F748-AE84-286620B50E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D356B0-39E3-8D4E-9FC9-AFF94EF557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A7890F0-98EE-9041-BFE4-AC7040099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E0BB12-4276-E045-85C5-6BD680BAC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0A91732-ABBB-DF46-A405-A0B9BE492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95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8A0029-5EFC-3747-BA85-CC79A8CA1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8068E03-BFDD-7145-8B05-DCBFF80544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EFDA7FC-738F-434E-A602-06ED9CCDC8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20AC7F-03C1-ED49-B6A8-E5BA02472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E98621-80F0-B142-B623-8495BFD71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85FC23-450B-FA48-B1FE-F1B1BF564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274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D7DC7B5-6FE0-7345-A1A7-D5D996A46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F739258-48F1-524F-BA3C-E77A27257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27F75E-BB0C-7241-BA92-B96DE36BB4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1710F-D973-7240-A41F-30A53B476D55}" type="datetimeFigureOut">
              <a:rPr kumimoji="1" lang="ja-JP" altLang="en-US" smtClean="0"/>
              <a:t>2021/1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A150A6-15F4-3E4F-A524-019D7272B8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D587EB-9308-AC47-B41D-81EF1A337C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9D251-14B6-B24D-92B8-9C4ADE7F65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970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cs00437_movie.mp4" descr="cs00437_movie.mp4">
            <a:hlinkClick r:id="" action="ppaction://media"/>
            <a:extLst>
              <a:ext uri="{FF2B5EF4-FFF2-40B4-BE49-F238E27FC236}">
                <a16:creationId xmlns:a16="http://schemas.microsoft.com/office/drawing/2014/main" id="{52508FAD-1900-F84E-9B02-4112102AD8C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796778" y="1576239"/>
            <a:ext cx="6598444" cy="471785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B68DA96-E19A-7848-8D70-A2D37D81272D}"/>
              </a:ext>
            </a:extLst>
          </p:cNvPr>
          <p:cNvSpPr txBox="1"/>
          <p:nvPr/>
        </p:nvSpPr>
        <p:spPr>
          <a:xfrm>
            <a:off x="3214442" y="500063"/>
            <a:ext cx="57631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Video S1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D EPR signal intensity map for the tumor-bearing leg.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42094E7-4EA1-BA49-9E7B-7EC3A3B78957}"/>
              </a:ext>
            </a:extLst>
          </p:cNvPr>
          <p:cNvSpPr txBox="1"/>
          <p:nvPr/>
        </p:nvSpPr>
        <p:spPr>
          <a:xfrm>
            <a:off x="5486400" y="3121223"/>
            <a:ext cx="4905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ail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5237985-0222-B54B-84B1-1A2F3CF57ED0}"/>
              </a:ext>
            </a:extLst>
          </p:cNvPr>
          <p:cNvSpPr txBox="1"/>
          <p:nvPr/>
        </p:nvSpPr>
        <p:spPr>
          <a:xfrm>
            <a:off x="5939729" y="4522993"/>
            <a:ext cx="18907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umor-bearing leg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ACF18A-8632-9244-94B1-CC9372B0DC41}"/>
              </a:ext>
            </a:extLst>
          </p:cNvPr>
          <p:cNvSpPr txBox="1"/>
          <p:nvPr/>
        </p:nvSpPr>
        <p:spPr>
          <a:xfrm>
            <a:off x="8401051" y="1714501"/>
            <a:ext cx="34427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edox-sensitive probe:</a:t>
            </a:r>
          </a:p>
          <a:p>
            <a:r>
              <a:rPr kumimoji="1"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-labaled perdeuterated 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Tempone</a:t>
            </a:r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-PDT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E3DD4F0-9BB2-5A4D-ADD2-3328DF3D23F3}"/>
              </a:ext>
            </a:extLst>
          </p:cNvPr>
          <p:cNvSpPr txBox="1"/>
          <p:nvPr/>
        </p:nvSpPr>
        <p:spPr>
          <a:xfrm>
            <a:off x="8401051" y="3096356"/>
            <a:ext cx="3020379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eld-of-view: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37.5 mm x 37.5 mm x 37.5 mm</a:t>
            </a:r>
          </a:p>
          <a:p>
            <a:endParaRPr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mage matrix: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96 x 96 x 96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9C89E96-8614-4C47-B267-C0A72D488B5D}"/>
              </a:ext>
            </a:extLst>
          </p:cNvPr>
          <p:cNvSpPr txBox="1"/>
          <p:nvPr/>
        </p:nvSpPr>
        <p:spPr>
          <a:xfrm>
            <a:off x="770570" y="1714501"/>
            <a:ext cx="27366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mpressed sensing-based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mage reconstruction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069074C-1CB0-F648-BCF8-69EC05398E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 flipV="1">
            <a:off x="2574317" y="3733766"/>
            <a:ext cx="2433265" cy="24074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DF3ECFC-5EBC-FE49-88CA-995380DEB15A}"/>
              </a:ext>
            </a:extLst>
          </p:cNvPr>
          <p:cNvSpPr txBox="1"/>
          <p:nvPr/>
        </p:nvSpPr>
        <p:spPr>
          <a:xfrm rot="16200000">
            <a:off x="2549399" y="3561416"/>
            <a:ext cx="156164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ignal intensity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rbitrary units)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16138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3</Words>
  <Application>Microsoft Macintosh PowerPoint</Application>
  <PresentationFormat>ワイド画面</PresentationFormat>
  <Paragraphs>16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田　拓</dc:creator>
  <cp:lastModifiedBy>平田　拓</cp:lastModifiedBy>
  <cp:revision>3</cp:revision>
  <dcterms:created xsi:type="dcterms:W3CDTF">2020-12-22T08:46:05Z</dcterms:created>
  <dcterms:modified xsi:type="dcterms:W3CDTF">2021-01-04T01:05:44Z</dcterms:modified>
</cp:coreProperties>
</file>